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8"/>
  </p:notesMasterIdLst>
  <p:sldIdLst>
    <p:sldId id="274" r:id="rId2"/>
    <p:sldId id="277" r:id="rId3"/>
    <p:sldId id="279" r:id="rId4"/>
    <p:sldId id="281" r:id="rId5"/>
    <p:sldId id="282" r:id="rId6"/>
    <p:sldId id="283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5979A1E0-9F41-CEAB-7299-C4E70739F79B}" name="Flores, Gilberto E" initials="FGE" userId="S::gilberto.flores@csun.edu::84e1d110-2e4f-4b3c-a7f3-ccf59f5506f2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30314"/>
    <p:restoredTop sz="85068"/>
  </p:normalViewPr>
  <p:slideViewPr>
    <p:cSldViewPr snapToGrid="0" snapToObjects="1">
      <p:cViewPr varScale="1">
        <p:scale>
          <a:sx n="97" d="100"/>
          <a:sy n="97" d="100"/>
        </p:scale>
        <p:origin x="32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microsoft.com/office/2018/10/relationships/authors" Target="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E7B9E84-9AE3-D744-8559-F516A4C71DD8}" type="datetimeFigureOut">
              <a:rPr lang="en-US" smtClean="0"/>
              <a:t>5/12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92B5C49-493B-E54F-A29C-6A738D7AAD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67905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err="1"/>
              <a:t>AlphaSCFAtests.rmd</a:t>
            </a:r>
            <a:endParaRPr lang="en-US" dirty="0"/>
          </a:p>
          <a:p>
            <a:r>
              <a:rPr lang="en-US" dirty="0"/>
              <a:t>OD_v5.tiff</a:t>
            </a:r>
          </a:p>
          <a:p>
            <a:r>
              <a:rPr lang="en-US" dirty="0"/>
              <a:t>pHdelta_v5.tiff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92B5C49-493B-E54F-A29C-6A738D7AADA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993249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err="1"/>
              <a:t>AlphaSCFAtests.rmd</a:t>
            </a:r>
            <a:endParaRPr lang="en-US" dirty="0"/>
          </a:p>
          <a:p>
            <a:r>
              <a:rPr lang="en-US" dirty="0"/>
              <a:t>Acetone_v2.tiff</a:t>
            </a:r>
          </a:p>
          <a:p>
            <a:r>
              <a:rPr lang="en-US" dirty="0"/>
              <a:t>Ethanol_v2.tiff</a:t>
            </a:r>
          </a:p>
          <a:p>
            <a:r>
              <a:rPr lang="en-US" dirty="0"/>
              <a:t>Methanol_v2.tiff</a:t>
            </a:r>
          </a:p>
          <a:p>
            <a:r>
              <a:rPr lang="en-US" dirty="0"/>
              <a:t>2-Propanol_v2.tiff</a:t>
            </a:r>
          </a:p>
          <a:p>
            <a:r>
              <a:rPr lang="en-US" dirty="0"/>
              <a:t>1-Butanol_v2.tiff</a:t>
            </a:r>
          </a:p>
          <a:p>
            <a:r>
              <a:rPr lang="en-US" dirty="0"/>
              <a:t>Isobutyrate_v2.tiff</a:t>
            </a:r>
          </a:p>
          <a:p>
            <a:r>
              <a:rPr lang="en-US" dirty="0"/>
              <a:t>Isovalerate_v2.tiff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Valerate_v2.tiff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Heptanoic_acid_v2.tiff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Hexanoic_acid_v2.tiff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92B5C49-493B-E54F-A29C-6A738D7AADA8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188477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err="1"/>
              <a:t>AlphaDiversityPlots.rmd</a:t>
            </a:r>
            <a:endParaRPr lang="en-US" dirty="0"/>
          </a:p>
          <a:p>
            <a:r>
              <a:rPr lang="en-US" dirty="0"/>
              <a:t>ObservedFeatures_PctLoss_BothN_v1.pdf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92B5C49-493B-E54F-A29C-6A738D7AADA8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291957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err="1"/>
              <a:t>Ash_Markdown_Barcharts_By_Phyla.Rmd</a:t>
            </a:r>
            <a:endParaRPr lang="en-US" dirty="0"/>
          </a:p>
          <a:p>
            <a:r>
              <a:rPr lang="en-US" dirty="0"/>
              <a:t>BacteroidotaTop_RelAbund_Nested_FamASV_1.pdf</a:t>
            </a:r>
          </a:p>
          <a:p>
            <a:r>
              <a:rPr lang="en-US" dirty="0"/>
              <a:t>DesulfobacterotaTop_RelAbund_Nested_FamASV_1.pdf</a:t>
            </a:r>
          </a:p>
          <a:p>
            <a:r>
              <a:rPr lang="en-US" dirty="0"/>
              <a:t>FirmicutesTop_RelAbund_Nested_FamASV_1.pdf</a:t>
            </a:r>
          </a:p>
          <a:p>
            <a:r>
              <a:rPr lang="en-US" dirty="0"/>
              <a:t>ProteobacteriaTop_RelAbund_Nested_FamASV_1.pdf</a:t>
            </a:r>
          </a:p>
          <a:p>
            <a:r>
              <a:rPr lang="en-US" dirty="0"/>
              <a:t>VerrucomicrobiotaTop_RelAbund_Nested_FamASV_1.pdf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92B5C49-493B-E54F-A29C-6A738D7AADA8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669471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err="1"/>
              <a:t>LefsePlots.Rmd</a:t>
            </a:r>
            <a:endParaRPr lang="en-US" dirty="0"/>
          </a:p>
          <a:p>
            <a:r>
              <a:rPr lang="en-US" dirty="0"/>
              <a:t>LEfSe_ASVs_Day10_v2.tiff</a:t>
            </a:r>
          </a:p>
          <a:p>
            <a:r>
              <a:rPr lang="en-US" dirty="0"/>
              <a:t>LEfSe_Genus_Day10_v1.tiff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92B5C49-493B-E54F-A29C-6A738D7AADA8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4043369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 err="1"/>
              <a:t>PlotBetaToPreviousTime.Rmd</a:t>
            </a:r>
            <a:endParaRPr lang="en-US" dirty="0"/>
          </a:p>
          <a:p>
            <a:r>
              <a:rPr lang="en-US" dirty="0"/>
              <a:t>Distance_to_previous_day_BC_Donor1_v2.tiff</a:t>
            </a:r>
          </a:p>
          <a:p>
            <a:r>
              <a:rPr lang="en-US" dirty="0"/>
              <a:t>Distance_to_previous_day_BC_Donor2_v2.tiff</a:t>
            </a:r>
          </a:p>
          <a:p>
            <a:r>
              <a:rPr lang="en-US" dirty="0"/>
              <a:t>Distance_to_previous_day_BC_Donor3_v2.tiff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92B5C49-493B-E54F-A29C-6A738D7AADA8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960705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FF4E8E-807A-F2B6-4F6C-34AB92D722E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2C3EC09-CECA-780B-DA12-8800283329A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0B7561-9D1C-CC1B-DD4A-D319867E81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357F6-697F-0C4F-B60A-DB4936FC4278}" type="datetimeFigureOut">
              <a:rPr lang="en-US" smtClean="0"/>
              <a:t>5/1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A6610C-87F7-FFCF-5154-0CF4E5760E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BFA71C-8C63-5B55-C7BF-A9B45D2A10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05484-29AA-DE40-B890-BA3307CA5D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88969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0948E7-3F49-2BBA-3B84-2EC93637DC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7A905B9-8C43-347D-79AC-1C5D740037B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80A649-DD8D-7CDC-62E3-3DE2B52246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357F6-697F-0C4F-B60A-DB4936FC4278}" type="datetimeFigureOut">
              <a:rPr lang="en-US" smtClean="0"/>
              <a:t>5/1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A3583D-2337-46DC-F79A-36C31534B5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F9B538-4DD0-5D08-0DB9-C85DF8EF9A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05484-29AA-DE40-B890-BA3307CA5D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39617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A627774-E6DB-2C38-7F9C-80CDC79C0DA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70AFF46-9620-23FC-3A6A-92010D3C6ED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BB2F49-DE48-2ED9-A4CF-83DD1D7FE8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357F6-697F-0C4F-B60A-DB4936FC4278}" type="datetimeFigureOut">
              <a:rPr lang="en-US" smtClean="0"/>
              <a:t>5/1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CB111D-8871-4CE4-45A4-CD8F474AE9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0CE45D-7352-B16C-CF04-EC4574E9E5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05484-29AA-DE40-B890-BA3307CA5D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7492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077EC5-5349-AABE-633E-D90AADCB52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7DC6FA-CFC2-C854-017D-67F2D6B6289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93B4AE-9FFE-8E62-302E-9F655FE524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357F6-697F-0C4F-B60A-DB4936FC4278}" type="datetimeFigureOut">
              <a:rPr lang="en-US" smtClean="0"/>
              <a:t>5/1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8E0D83-9A35-892A-7B31-D7C1007958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8381AB-4FEB-AC3E-7AC1-8284ED7B82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05484-29AA-DE40-B890-BA3307CA5D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46674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F37F25-F934-7C3B-BC2D-67053729FF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3DB7E48-7ECC-E3EE-0570-DE4A7DBB1DD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DFE087-502C-D7D1-8EB5-3BB9F555BE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357F6-697F-0C4F-B60A-DB4936FC4278}" type="datetimeFigureOut">
              <a:rPr lang="en-US" smtClean="0"/>
              <a:t>5/1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57501B-B83F-80A9-371A-641C081A67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E3FEBB-283C-427D-F576-06C3BA1806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05484-29AA-DE40-B890-BA3307CA5D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12512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228BE0-A2F8-422B-DFC4-AF09A3EA90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E6BD6F0-1F9A-213F-A77B-44865C0FE68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3919913-E39D-4403-75CA-582B7DDB879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7219F12-A182-E09E-781C-DAB0646C67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357F6-697F-0C4F-B60A-DB4936FC4278}" type="datetimeFigureOut">
              <a:rPr lang="en-US" smtClean="0"/>
              <a:t>5/12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0BC58DD-CBE2-F5B8-2A48-B2963FDF39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140A15-E772-321A-ABCB-8A49F1F371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05484-29AA-DE40-B890-BA3307CA5D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59650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42D863-29DC-CB17-EDCE-1BA8A7F348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516A740-C8A9-3F4D-68C4-FF4A0488D0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C78589B-BB2B-FB78-71BA-9F306B781FF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D505FD4-970A-45BA-015B-DCA81F3B5C5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747961B-DBEB-6E42-05FD-1DA75F980DA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96C5A05-DBC6-0879-30FC-3E2CB4F3F1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357F6-697F-0C4F-B60A-DB4936FC4278}" type="datetimeFigureOut">
              <a:rPr lang="en-US" smtClean="0"/>
              <a:t>5/12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89AC4A0-0B8F-F00E-0D43-352A52BD8D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7CDB34E-DF42-0AE7-737D-CEA5B08780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05484-29AA-DE40-B890-BA3307CA5D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21433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433B82-3CF9-F25C-D7D6-FFE91A638A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BAA8D23-E072-F189-AC9B-0987622D32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357F6-697F-0C4F-B60A-DB4936FC4278}" type="datetimeFigureOut">
              <a:rPr lang="en-US" smtClean="0"/>
              <a:t>5/12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5A5FE33-411D-D652-B79C-6139BB6903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8B78A13-286D-9DF2-303B-82B906AB36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05484-29AA-DE40-B890-BA3307CA5D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81145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75BBC2D-5ACD-23DD-61A3-4734754C99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357F6-697F-0C4F-B60A-DB4936FC4278}" type="datetimeFigureOut">
              <a:rPr lang="en-US" smtClean="0"/>
              <a:t>5/12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3A2DF44-1667-320C-7BB7-563C823C90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7D4A023-97F7-5836-CC68-AB76E0F703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05484-29AA-DE40-B890-BA3307CA5D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09655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5A6E4A-17E2-4326-C3F9-8EFAD7F413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63A3888-1A0E-A7A1-1F7F-A656FB253F2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A7E7AFC-A082-1F5B-F2C7-D8B6EE09FF0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45E56C2-453A-D3AD-3DDD-F7CFCDDEB5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357F6-697F-0C4F-B60A-DB4936FC4278}" type="datetimeFigureOut">
              <a:rPr lang="en-US" smtClean="0"/>
              <a:t>5/12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4B6DADB-4386-D3AB-37F9-79C22AA613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26C6BD8-ECD4-C069-7E3D-0A4B5700B8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05484-29AA-DE40-B890-BA3307CA5D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27822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D781D7-160A-1F15-22A1-0935E027C4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135A8DF-301A-9C4B-C8B4-C4B34B2484B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8D87A78-524E-A4C8-620A-D4FC3270DE6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5241914-9FCC-BC2A-D4A0-FB076439E3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F357F6-697F-0C4F-B60A-DB4936FC4278}" type="datetimeFigureOut">
              <a:rPr lang="en-US" smtClean="0"/>
              <a:t>5/12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6DCD7B7-710A-520E-1F0E-238A991BCC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66B1E1B-60B6-1D7A-E0F0-285D9B8A5D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05484-29AA-DE40-B890-BA3307CA5D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69602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2596B7A-DCD3-04AA-AF90-1FF893AD5B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FE9C94A-ECC5-A275-3F54-79BDFA8F23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403FC1-6568-59FD-71CC-20A0E67F100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F357F6-697F-0C4F-B60A-DB4936FC4278}" type="datetimeFigureOut">
              <a:rPr lang="en-US" smtClean="0"/>
              <a:t>5/12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BE31F50-966D-F3D1-AED9-222E36AFCC0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8F931A-5CC8-BA35-F247-3EFA50AA541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C05484-29AA-DE40-B890-BA3307CA5D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23256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tiff"/><Relationship Id="rId4" Type="http://schemas.openxmlformats.org/officeDocument/2006/relationships/image" Target="../media/image7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1">
            <a:extLst>
              <a:ext uri="{FF2B5EF4-FFF2-40B4-BE49-F238E27FC236}">
                <a16:creationId xmlns:a16="http://schemas.microsoft.com/office/drawing/2014/main" id="{50C5B1DF-E3AC-90BB-BE62-A945718419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49594" y="436220"/>
            <a:ext cx="2664667" cy="303097"/>
          </a:xfrm>
        </p:spPr>
        <p:txBody>
          <a:bodyPr>
            <a:normAutofit fontScale="90000"/>
          </a:bodyPr>
          <a:lstStyle/>
          <a:p>
            <a:r>
              <a:rPr lang="en-US" sz="2000" dirty="0"/>
              <a:t>Supplemental Figure 1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C0B0F5BD-668C-259D-6064-6A3FE28DB53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97835" y="889971"/>
            <a:ext cx="10788210" cy="52457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557081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>
            <a:extLst>
              <a:ext uri="{FF2B5EF4-FFF2-40B4-BE49-F238E27FC236}">
                <a16:creationId xmlns:a16="http://schemas.microsoft.com/office/drawing/2014/main" id="{6A3953F9-F711-D41C-9B36-DFA02FEACEAB}"/>
              </a:ext>
            </a:extLst>
          </p:cNvPr>
          <p:cNvSpPr txBox="1">
            <a:spLocks/>
          </p:cNvSpPr>
          <p:nvPr/>
        </p:nvSpPr>
        <p:spPr>
          <a:xfrm>
            <a:off x="415635" y="463044"/>
            <a:ext cx="10952020" cy="36933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>
              <a:lnSpc>
                <a:spcPct val="90000"/>
              </a:lnSpc>
              <a:spcBef>
                <a:spcPct val="0"/>
              </a:spcBef>
              <a:buNone/>
              <a:defRPr sz="4000">
                <a:latin typeface="+mj-lt"/>
                <a:ea typeface="+mj-ea"/>
                <a:cs typeface="+mj-cs"/>
              </a:defRPr>
            </a:lvl1pPr>
          </a:lstStyle>
          <a:p>
            <a:r>
              <a:rPr lang="en-US" sz="1800" dirty="0"/>
              <a:t>Supplemental Figure 2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03F54030-82EB-4760-DAB6-F78510B6775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58078" y="930615"/>
            <a:ext cx="10781077" cy="53111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012259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le 1">
            <a:extLst>
              <a:ext uri="{FF2B5EF4-FFF2-40B4-BE49-F238E27FC236}">
                <a16:creationId xmlns:a16="http://schemas.microsoft.com/office/drawing/2014/main" id="{A34F3F23-8C7E-E37F-CA19-6E68C89853CF}"/>
              </a:ext>
            </a:extLst>
          </p:cNvPr>
          <p:cNvSpPr txBox="1">
            <a:spLocks/>
          </p:cNvSpPr>
          <p:nvPr/>
        </p:nvSpPr>
        <p:spPr>
          <a:xfrm>
            <a:off x="415635" y="463044"/>
            <a:ext cx="10952020" cy="78846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>
              <a:lnSpc>
                <a:spcPct val="90000"/>
              </a:lnSpc>
              <a:spcBef>
                <a:spcPct val="0"/>
              </a:spcBef>
              <a:buNone/>
              <a:defRPr sz="4000">
                <a:latin typeface="+mj-lt"/>
                <a:ea typeface="+mj-ea"/>
                <a:cs typeface="+mj-cs"/>
              </a:defRPr>
            </a:lvl1pPr>
          </a:lstStyle>
          <a:p>
            <a:r>
              <a:rPr lang="en-US" sz="1800" dirty="0"/>
              <a:t>Supplemental Figure 3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4FDE3F23-4FF9-B34E-28FA-31E0FFB8CE6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66643" y="1251511"/>
            <a:ext cx="9901012" cy="49505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341738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1">
            <a:extLst>
              <a:ext uri="{FF2B5EF4-FFF2-40B4-BE49-F238E27FC236}">
                <a16:creationId xmlns:a16="http://schemas.microsoft.com/office/drawing/2014/main" id="{E9D16653-4C9C-E24F-B717-535E218B03E5}"/>
              </a:ext>
            </a:extLst>
          </p:cNvPr>
          <p:cNvSpPr txBox="1">
            <a:spLocks/>
          </p:cNvSpPr>
          <p:nvPr/>
        </p:nvSpPr>
        <p:spPr>
          <a:xfrm>
            <a:off x="415635" y="-44953"/>
            <a:ext cx="10952020" cy="78846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>
              <a:lnSpc>
                <a:spcPct val="90000"/>
              </a:lnSpc>
              <a:spcBef>
                <a:spcPct val="0"/>
              </a:spcBef>
              <a:buNone/>
              <a:defRPr sz="4000">
                <a:latin typeface="+mj-lt"/>
                <a:ea typeface="+mj-ea"/>
                <a:cs typeface="+mj-cs"/>
              </a:defRPr>
            </a:lvl1pPr>
          </a:lstStyle>
          <a:p>
            <a:r>
              <a:rPr lang="en-US" sz="1800" dirty="0"/>
              <a:t>Supplemental Figure 4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9B7CC4FC-FAF4-7971-3193-0D9A651F3A7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5635" y="743514"/>
            <a:ext cx="11449655" cy="49814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0733757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>
            <a:extLst>
              <a:ext uri="{FF2B5EF4-FFF2-40B4-BE49-F238E27FC236}">
                <a16:creationId xmlns:a16="http://schemas.microsoft.com/office/drawing/2014/main" id="{17635C0D-F31E-2AAB-D947-F98E3E138F8F}"/>
              </a:ext>
            </a:extLst>
          </p:cNvPr>
          <p:cNvSpPr txBox="1">
            <a:spLocks/>
          </p:cNvSpPr>
          <p:nvPr/>
        </p:nvSpPr>
        <p:spPr>
          <a:xfrm>
            <a:off x="415635" y="463044"/>
            <a:ext cx="10952020" cy="78846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>
              <a:lnSpc>
                <a:spcPct val="90000"/>
              </a:lnSpc>
              <a:spcBef>
                <a:spcPct val="0"/>
              </a:spcBef>
              <a:buNone/>
              <a:defRPr sz="4000">
                <a:latin typeface="+mj-lt"/>
                <a:ea typeface="+mj-ea"/>
                <a:cs typeface="+mj-cs"/>
              </a:defRPr>
            </a:lvl1pPr>
          </a:lstStyle>
          <a:p>
            <a:r>
              <a:rPr lang="en-US" sz="1800" dirty="0"/>
              <a:t>Supplemental Figure 5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82B25B3B-FC64-CC29-E280-04828D33D26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46790" y="126678"/>
            <a:ext cx="6577063" cy="67313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0002146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1">
            <a:extLst>
              <a:ext uri="{FF2B5EF4-FFF2-40B4-BE49-F238E27FC236}">
                <a16:creationId xmlns:a16="http://schemas.microsoft.com/office/drawing/2014/main" id="{B26CCDAF-EF4A-E31A-F67E-E00E4293E31C}"/>
              </a:ext>
            </a:extLst>
          </p:cNvPr>
          <p:cNvSpPr txBox="1">
            <a:spLocks/>
          </p:cNvSpPr>
          <p:nvPr/>
        </p:nvSpPr>
        <p:spPr>
          <a:xfrm>
            <a:off x="415635" y="463044"/>
            <a:ext cx="10952020" cy="36933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>
              <a:lnSpc>
                <a:spcPct val="90000"/>
              </a:lnSpc>
              <a:spcBef>
                <a:spcPct val="0"/>
              </a:spcBef>
              <a:buNone/>
              <a:defRPr sz="4000">
                <a:latin typeface="+mj-lt"/>
                <a:ea typeface="+mj-ea"/>
                <a:cs typeface="+mj-cs"/>
              </a:defRPr>
            </a:lvl1pPr>
          </a:lstStyle>
          <a:p>
            <a:r>
              <a:rPr lang="en-US" sz="1800" dirty="0"/>
              <a:t>Supplemental Figure 6</a:t>
            </a:r>
          </a:p>
        </p:txBody>
      </p:sp>
      <p:pic>
        <p:nvPicPr>
          <p:cNvPr id="3" name="Picture 2" descr="Chart, histogram&#10;&#10;Description automatically generated">
            <a:extLst>
              <a:ext uri="{FF2B5EF4-FFF2-40B4-BE49-F238E27FC236}">
                <a16:creationId xmlns:a16="http://schemas.microsoft.com/office/drawing/2014/main" id="{7DB29C21-38B8-9D95-048D-AF05206BC960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57740" y="1771049"/>
            <a:ext cx="3699164" cy="3699164"/>
          </a:xfrm>
          <a:prstGeom prst="rect">
            <a:avLst/>
          </a:prstGeom>
        </p:spPr>
      </p:pic>
      <p:pic>
        <p:nvPicPr>
          <p:cNvPr id="10" name="Picture 9" descr="Chart, line chart&#10;&#10;Description automatically generated">
            <a:extLst>
              <a:ext uri="{FF2B5EF4-FFF2-40B4-BE49-F238E27FC236}">
                <a16:creationId xmlns:a16="http://schemas.microsoft.com/office/drawing/2014/main" id="{FB04DAF2-02CD-27C3-E8D1-E9F4C86078D7}"/>
              </a:ext>
            </a:extLst>
          </p:cNvPr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180608" y="1771049"/>
            <a:ext cx="3699164" cy="3699164"/>
          </a:xfrm>
          <a:prstGeom prst="rect">
            <a:avLst/>
          </a:prstGeom>
        </p:spPr>
      </p:pic>
      <p:pic>
        <p:nvPicPr>
          <p:cNvPr id="12" name="Picture 11" descr="Chart, line chart&#10;&#10;Description automatically generated">
            <a:extLst>
              <a:ext uri="{FF2B5EF4-FFF2-40B4-BE49-F238E27FC236}">
                <a16:creationId xmlns:a16="http://schemas.microsoft.com/office/drawing/2014/main" id="{CE4EB8D6-9B00-FC84-DA5F-FA24947E8247}"/>
              </a:ext>
            </a:extLst>
          </p:cNvPr>
          <p:cNvPicPr>
            <a:picLocks noChangeAspect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7903477" y="1771049"/>
            <a:ext cx="3699164" cy="3699164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B8BC1BF-C4E1-F518-1159-797A2C5E15B7}"/>
              </a:ext>
            </a:extLst>
          </p:cNvPr>
          <p:cNvSpPr txBox="1">
            <a:spLocks noChangeAspect="1"/>
          </p:cNvSpPr>
          <p:nvPr/>
        </p:nvSpPr>
        <p:spPr>
          <a:xfrm>
            <a:off x="457740" y="5100881"/>
            <a:ext cx="3361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C98BD6C-2DF9-B6F7-C56C-8193ED15ADD2}"/>
              </a:ext>
            </a:extLst>
          </p:cNvPr>
          <p:cNvSpPr txBox="1">
            <a:spLocks noChangeAspect="1"/>
          </p:cNvSpPr>
          <p:nvPr/>
        </p:nvSpPr>
        <p:spPr>
          <a:xfrm>
            <a:off x="4180608" y="5100881"/>
            <a:ext cx="3276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9F611DE-22C2-BC44-58FD-CC7F628475DE}"/>
              </a:ext>
            </a:extLst>
          </p:cNvPr>
          <p:cNvSpPr txBox="1">
            <a:spLocks noChangeAspect="1"/>
          </p:cNvSpPr>
          <p:nvPr/>
        </p:nvSpPr>
        <p:spPr>
          <a:xfrm>
            <a:off x="7903477" y="5100881"/>
            <a:ext cx="3276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8571109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397</TotalTime>
  <Words>244</Words>
  <Application>Microsoft Macintosh PowerPoint</Application>
  <PresentationFormat>Widescreen</PresentationFormat>
  <Paragraphs>44</Paragraphs>
  <Slides>6</Slides>
  <Notes>6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Supplemental Figure 1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ucin Community Paper</dc:title>
  <dc:creator>Fricker , Ashwana</dc:creator>
  <cp:lastModifiedBy>Fricker , Ashwana</cp:lastModifiedBy>
  <cp:revision>50</cp:revision>
  <dcterms:created xsi:type="dcterms:W3CDTF">2022-06-25T04:26:37Z</dcterms:created>
  <dcterms:modified xsi:type="dcterms:W3CDTF">2023-05-13T01:18:01Z</dcterms:modified>
</cp:coreProperties>
</file>